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BFFF"/>
    <a:srgbClr val="00B2EE"/>
    <a:srgbClr val="E26714"/>
    <a:srgbClr val="C39B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93D81CF-94F2-401A-BA57-92F5A7B2D0C5}" styleName="보통 스타일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>
        <p:scale>
          <a:sx n="200" d="100"/>
          <a:sy n="200" d="100"/>
        </p:scale>
        <p:origin x="336" y="-763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5E225E-72F0-4853-92EE-6FDCB98569E6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C97A42-A716-4F81-9DB1-CE1E91B500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7540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1pPr>
    <a:lvl2pPr marL="404440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2pPr>
    <a:lvl3pPr marL="808879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3pPr>
    <a:lvl4pPr marL="1213319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4pPr>
    <a:lvl5pPr marL="1617758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5pPr>
    <a:lvl6pPr marL="2022198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6pPr>
    <a:lvl7pPr marL="2426637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7pPr>
    <a:lvl8pPr marL="2831076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8pPr>
    <a:lvl9pPr marL="3235516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8289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5328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0726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3505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1201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49105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4226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0914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45101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2725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1605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070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5" name="직선 화살표 연결선 34"/>
          <p:cNvCxnSpPr>
            <a:stCxn id="41" idx="2"/>
            <a:endCxn id="49" idx="0"/>
          </p:cNvCxnSpPr>
          <p:nvPr/>
        </p:nvCxnSpPr>
        <p:spPr>
          <a:xfrm>
            <a:off x="5629284" y="2210184"/>
            <a:ext cx="0" cy="4935399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화살표 연결선 35"/>
          <p:cNvCxnSpPr>
            <a:stCxn id="40" idx="2"/>
            <a:endCxn id="48" idx="0"/>
          </p:cNvCxnSpPr>
          <p:nvPr/>
        </p:nvCxnSpPr>
        <p:spPr>
          <a:xfrm>
            <a:off x="1167605" y="2210184"/>
            <a:ext cx="0" cy="4935399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직사각형 36"/>
          <p:cNvSpPr/>
          <p:nvPr/>
        </p:nvSpPr>
        <p:spPr>
          <a:xfrm>
            <a:off x="293530" y="8337337"/>
            <a:ext cx="6336786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0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</a:t>
            </a:r>
            <a:r>
              <a:rPr lang="en-US" altLang="ko-KR" sz="10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diagram illustrating the characteristics of the EP, REC.BCG+, and DP.BCG+ subtypes of non-muscle-invasive bladder cancer. BCG, Bacillus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mette-Guérin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GU,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omically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stable; RFS, recurrence-free survival; PFS, progression-free survival; NA, not available.</a:t>
            </a:r>
            <a:endParaRPr lang="ko-KR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모서리가 둥근 직사각형 38"/>
          <p:cNvSpPr/>
          <p:nvPr/>
        </p:nvSpPr>
        <p:spPr>
          <a:xfrm>
            <a:off x="2452106" y="438565"/>
            <a:ext cx="1916694" cy="673241"/>
          </a:xfrm>
          <a:prstGeom prst="round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sz="1399" dirty="0" smtClean="0">
                <a:latin typeface="Arial" panose="020B0604020202020204" pitchFamily="34" charset="0"/>
                <a:cs typeface="Arial" panose="020B0604020202020204" pitchFamily="34" charset="0"/>
              </a:rPr>
              <a:t>Non-muscle invasive bladder cancer</a:t>
            </a:r>
            <a:endParaRPr lang="ko-KR" altLang="en-US" sz="13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모서리가 둥근 직사각형 39"/>
          <p:cNvSpPr/>
          <p:nvPr/>
        </p:nvSpPr>
        <p:spPr>
          <a:xfrm>
            <a:off x="169234" y="1817330"/>
            <a:ext cx="1996742" cy="392854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P subtype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모서리가 둥근 직사각형 40"/>
          <p:cNvSpPr/>
          <p:nvPr/>
        </p:nvSpPr>
        <p:spPr>
          <a:xfrm>
            <a:off x="4657695" y="1817330"/>
            <a:ext cx="1943178" cy="392854"/>
          </a:xfrm>
          <a:prstGeom prst="round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P.BCG+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ubtype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꺾인 연결선 41"/>
          <p:cNvCxnSpPr>
            <a:stCxn id="39" idx="2"/>
            <a:endCxn id="40" idx="0"/>
          </p:cNvCxnSpPr>
          <p:nvPr/>
        </p:nvCxnSpPr>
        <p:spPr>
          <a:xfrm rot="5400000">
            <a:off x="1936267" y="343144"/>
            <a:ext cx="705524" cy="2242848"/>
          </a:xfrm>
          <a:prstGeom prst="bentConnector3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꺾인 연결선 42"/>
          <p:cNvCxnSpPr>
            <a:stCxn id="39" idx="2"/>
            <a:endCxn id="41" idx="0"/>
          </p:cNvCxnSpPr>
          <p:nvPr/>
        </p:nvCxnSpPr>
        <p:spPr>
          <a:xfrm rot="16200000" flipH="1">
            <a:off x="4167106" y="355152"/>
            <a:ext cx="705524" cy="2218831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모서리가 둥근 직사각형 45"/>
          <p:cNvSpPr/>
          <p:nvPr/>
        </p:nvSpPr>
        <p:spPr>
          <a:xfrm>
            <a:off x="169234" y="2497858"/>
            <a:ext cx="1996742" cy="1168288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ko-KR" sz="1200" u="sng" dirty="0">
                <a:latin typeface="Arial" panose="020B0604020202020204" pitchFamily="34" charset="0"/>
                <a:cs typeface="Arial" panose="020B0604020202020204" pitchFamily="34" charset="0"/>
              </a:rPr>
              <a:t>Enriched </a:t>
            </a:r>
            <a:r>
              <a:rPr lang="en-US" altLang="ko-KR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pathways:</a:t>
            </a:r>
            <a:endParaRPr lang="en-US" altLang="ko-KR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D-1/PD-L1 cancer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mmunotherapy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NA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amage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tuin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signaling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athways</a:t>
            </a:r>
            <a:endParaRPr lang="en-US" altLang="ko-KR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enescence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athways</a:t>
            </a:r>
          </a:p>
        </p:txBody>
      </p:sp>
      <p:sp>
        <p:nvSpPr>
          <p:cNvPr id="47" name="모서리가 둥근 직사각형 46"/>
          <p:cNvSpPr/>
          <p:nvPr/>
        </p:nvSpPr>
        <p:spPr>
          <a:xfrm>
            <a:off x="4657694" y="2459756"/>
            <a:ext cx="1998259" cy="1073614"/>
          </a:xfrm>
          <a:prstGeom prst="round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ko-KR" sz="1200" u="sng" dirty="0">
                <a:latin typeface="Arial" panose="020B0604020202020204" pitchFamily="34" charset="0"/>
                <a:cs typeface="Arial" panose="020B0604020202020204" pitchFamily="34" charset="0"/>
              </a:rPr>
              <a:t>Enriched pathways 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ycle control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hromosomal replication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yclins and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ll cycle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gulatio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모서리가 둥근 직사각형 47"/>
          <p:cNvSpPr/>
          <p:nvPr/>
        </p:nvSpPr>
        <p:spPr>
          <a:xfrm>
            <a:off x="169234" y="7145583"/>
            <a:ext cx="1996742" cy="759278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ko-KR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Treatment:</a:t>
            </a:r>
            <a:endParaRPr lang="en-US" altLang="ko-KR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모서리가 둥근 직사각형 48"/>
          <p:cNvSpPr/>
          <p:nvPr/>
        </p:nvSpPr>
        <p:spPr>
          <a:xfrm>
            <a:off x="4657695" y="7145583"/>
            <a:ext cx="1943178" cy="778493"/>
          </a:xfrm>
          <a:prstGeom prst="round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ko-KR" sz="1200" u="sng" dirty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en-US" altLang="ko-KR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en-US" altLang="ko-KR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nsitive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endParaRPr lang="en-US" altLang="ko-KR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CG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herapy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모서리가 둥근 직사각형 53"/>
          <p:cNvSpPr/>
          <p:nvPr/>
        </p:nvSpPr>
        <p:spPr>
          <a:xfrm>
            <a:off x="169234" y="6161745"/>
            <a:ext cx="1996742" cy="547728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ko-KR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Prognosis:</a:t>
            </a:r>
          </a:p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quivocal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모서리가 둥근 직사각형 54"/>
          <p:cNvSpPr/>
          <p:nvPr/>
        </p:nvSpPr>
        <p:spPr>
          <a:xfrm>
            <a:off x="4657695" y="6174022"/>
            <a:ext cx="1943178" cy="539085"/>
          </a:xfrm>
          <a:prstGeom prst="round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ko-KR" sz="1200" u="sng" dirty="0">
                <a:latin typeface="Arial" panose="020B0604020202020204" pitchFamily="34" charset="0"/>
                <a:cs typeface="Arial" panose="020B0604020202020204" pitchFamily="34" charset="0"/>
              </a:rPr>
              <a:t>Prognosis :</a:t>
            </a:r>
          </a:p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oor PFS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직선 화살표 연결선 57"/>
          <p:cNvCxnSpPr>
            <a:stCxn id="59" idx="2"/>
            <a:endCxn id="62" idx="0"/>
          </p:cNvCxnSpPr>
          <p:nvPr/>
        </p:nvCxnSpPr>
        <p:spPr>
          <a:xfrm>
            <a:off x="3411834" y="2210184"/>
            <a:ext cx="0" cy="4935399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모서리가 둥근 직사각형 58"/>
          <p:cNvSpPr/>
          <p:nvPr/>
        </p:nvSpPr>
        <p:spPr>
          <a:xfrm>
            <a:off x="2413463" y="1817330"/>
            <a:ext cx="1996742" cy="392854"/>
          </a:xfrm>
          <a:prstGeom prst="round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C.BCG+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ubtype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모서리가 둥근 직사각형 60"/>
          <p:cNvSpPr/>
          <p:nvPr/>
        </p:nvSpPr>
        <p:spPr>
          <a:xfrm>
            <a:off x="2413463" y="2497857"/>
            <a:ext cx="1996742" cy="1032841"/>
          </a:xfrm>
          <a:prstGeom prst="round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ko-KR" sz="1200" u="sng" dirty="0">
                <a:latin typeface="Arial" panose="020B0604020202020204" pitchFamily="34" charset="0"/>
                <a:cs typeface="Arial" panose="020B0604020202020204" pitchFamily="34" charset="0"/>
              </a:rPr>
              <a:t>Enriched pathways 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1 pathway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IF2 signaling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nt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β-catenin signaling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steoarthritis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athways</a:t>
            </a:r>
          </a:p>
        </p:txBody>
      </p:sp>
      <p:sp>
        <p:nvSpPr>
          <p:cNvPr id="62" name="모서리가 둥근 직사각형 61"/>
          <p:cNvSpPr/>
          <p:nvPr/>
        </p:nvSpPr>
        <p:spPr>
          <a:xfrm>
            <a:off x="2413463" y="7145583"/>
            <a:ext cx="1996742" cy="759278"/>
          </a:xfrm>
          <a:prstGeom prst="round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ko-KR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Treatment:</a:t>
            </a:r>
            <a:endParaRPr lang="en-US" altLang="ko-KR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nsitive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endParaRPr lang="en-US" altLang="ko-KR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CG therapy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모서리가 둥근 직사각형 64"/>
          <p:cNvSpPr/>
          <p:nvPr/>
        </p:nvSpPr>
        <p:spPr>
          <a:xfrm>
            <a:off x="2413463" y="6161745"/>
            <a:ext cx="1996742" cy="547728"/>
          </a:xfrm>
          <a:prstGeom prst="round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ko-KR" sz="1200" u="sng" dirty="0">
                <a:latin typeface="Arial" panose="020B0604020202020204" pitchFamily="34" charset="0"/>
                <a:cs typeface="Arial" panose="020B0604020202020204" pitchFamily="34" charset="0"/>
              </a:rPr>
              <a:t>Prognosis </a:t>
            </a:r>
            <a:r>
              <a:rPr lang="en-US" altLang="ko-KR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oor RFS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모서리가 둥근 직사각형 68"/>
          <p:cNvSpPr/>
          <p:nvPr/>
        </p:nvSpPr>
        <p:spPr>
          <a:xfrm>
            <a:off x="169234" y="3981136"/>
            <a:ext cx="1996742" cy="605176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ko-KR" sz="1200" u="sng" dirty="0">
                <a:latin typeface="Arial" panose="020B0604020202020204" pitchFamily="34" charset="0"/>
                <a:cs typeface="Arial" panose="020B0604020202020204" pitchFamily="34" charset="0"/>
              </a:rPr>
              <a:t>Lund </a:t>
            </a:r>
            <a:r>
              <a:rPr lang="en-US" altLang="ko-KR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taxonomy </a:t>
            </a:r>
            <a:r>
              <a:rPr lang="en-US" altLang="ko-KR" sz="1200" u="sng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algn="ctr"/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robasal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r GU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enriched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모서리가 둥근 직사각형 69"/>
          <p:cNvSpPr/>
          <p:nvPr/>
        </p:nvSpPr>
        <p:spPr>
          <a:xfrm>
            <a:off x="4657695" y="3993415"/>
            <a:ext cx="1943178" cy="592898"/>
          </a:xfrm>
          <a:prstGeom prst="round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ko-KR" sz="1200" u="sng" dirty="0">
                <a:latin typeface="Arial" panose="020B0604020202020204" pitchFamily="34" charset="0"/>
                <a:cs typeface="Arial" panose="020B0604020202020204" pitchFamily="34" charset="0"/>
              </a:rPr>
              <a:t>Lund taxonomy :</a:t>
            </a:r>
          </a:p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U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enriched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모서리가 둥근 직사각형 70"/>
          <p:cNvSpPr/>
          <p:nvPr/>
        </p:nvSpPr>
        <p:spPr>
          <a:xfrm>
            <a:off x="2413463" y="3981136"/>
            <a:ext cx="1996742" cy="605176"/>
          </a:xfrm>
          <a:prstGeom prst="round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ko-KR" sz="1200" u="sng" dirty="0">
                <a:latin typeface="Arial" panose="020B0604020202020204" pitchFamily="34" charset="0"/>
                <a:cs typeface="Arial" panose="020B0604020202020204" pitchFamily="34" charset="0"/>
              </a:rPr>
              <a:t>Lund taxonomy :</a:t>
            </a:r>
          </a:p>
          <a:p>
            <a:pPr algn="ctr"/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filterated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enriched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모서리가 둥근 직사각형 71"/>
          <p:cNvSpPr/>
          <p:nvPr/>
        </p:nvSpPr>
        <p:spPr>
          <a:xfrm>
            <a:off x="169234" y="5055260"/>
            <a:ext cx="1996742" cy="605176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ko-KR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UROMOL subtype </a:t>
            </a:r>
            <a:r>
              <a:rPr lang="en-US" altLang="ko-KR" sz="1200" u="sng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lass 3 (early basal-like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모서리가 둥근 직사각형 72"/>
          <p:cNvSpPr/>
          <p:nvPr/>
        </p:nvSpPr>
        <p:spPr>
          <a:xfrm>
            <a:off x="4657695" y="5067539"/>
            <a:ext cx="1943178" cy="592898"/>
          </a:xfrm>
          <a:prstGeom prst="round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ko-KR" sz="1200" u="sng" dirty="0">
                <a:latin typeface="Arial" panose="020B0604020202020204" pitchFamily="34" charset="0"/>
                <a:cs typeface="Arial" panose="020B0604020202020204" pitchFamily="34" charset="0"/>
              </a:rPr>
              <a:t>UROMOL subtype :</a:t>
            </a:r>
          </a:p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lass 2 (luminal CIS-like)</a:t>
            </a:r>
          </a:p>
        </p:txBody>
      </p:sp>
      <p:sp>
        <p:nvSpPr>
          <p:cNvPr id="74" name="모서리가 둥근 직사각형 73"/>
          <p:cNvSpPr/>
          <p:nvPr/>
        </p:nvSpPr>
        <p:spPr>
          <a:xfrm>
            <a:off x="2413463" y="5055260"/>
            <a:ext cx="1996742" cy="605176"/>
          </a:xfrm>
          <a:prstGeom prst="round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ko-KR" sz="1200" u="sng" dirty="0">
                <a:latin typeface="Arial" panose="020B0604020202020204" pitchFamily="34" charset="0"/>
                <a:cs typeface="Arial" panose="020B0604020202020204" pitchFamily="34" charset="0"/>
              </a:rPr>
              <a:t>UROMOL subtype :</a:t>
            </a:r>
          </a:p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lass 1 (luminal)</a:t>
            </a:r>
          </a:p>
        </p:txBody>
      </p:sp>
      <p:cxnSp>
        <p:nvCxnSpPr>
          <p:cNvPr id="90" name="꺾인 연결선 89"/>
          <p:cNvCxnSpPr>
            <a:stCxn id="39" idx="2"/>
            <a:endCxn id="59" idx="0"/>
          </p:cNvCxnSpPr>
          <p:nvPr/>
        </p:nvCxnSpPr>
        <p:spPr>
          <a:xfrm rot="16200000" flipH="1">
            <a:off x="3058381" y="1463877"/>
            <a:ext cx="705524" cy="1381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257497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07</TotalTime>
  <Words>168</Words>
  <Application>Microsoft Office PowerPoint</Application>
  <PresentationFormat>A4 용지(210x297mm)</PresentationFormat>
  <Paragraphs>4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eon-Kyu Kim</dc:creator>
  <cp:lastModifiedBy>Seon-Kyu Kim</cp:lastModifiedBy>
  <cp:revision>1807</cp:revision>
  <dcterms:created xsi:type="dcterms:W3CDTF">2018-02-19T05:53:37Z</dcterms:created>
  <dcterms:modified xsi:type="dcterms:W3CDTF">2021-01-21T05:23:19Z</dcterms:modified>
</cp:coreProperties>
</file>